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393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00CC00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7853C-536D-4A76-A0AE-DD22124D55A5}" styleName="テーマ スタイル 1 - アクセント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4954" autoAdjust="0"/>
  </p:normalViewPr>
  <p:slideViewPr>
    <p:cSldViewPr snapToGrid="0">
      <p:cViewPr varScale="1">
        <p:scale>
          <a:sx n="74" d="100"/>
          <a:sy n="74" d="100"/>
        </p:scale>
        <p:origin x="1642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5" y="3"/>
            <a:ext cx="2949786" cy="498693"/>
          </a:xfrm>
          <a:prstGeom prst="rect">
            <a:avLst/>
          </a:prstGeom>
        </p:spPr>
        <p:txBody>
          <a:bodyPr vert="horz" lIns="95624" tIns="47814" rIns="95624" bIns="47814" rtlCol="0"/>
          <a:lstStyle>
            <a:lvl1pPr algn="l">
              <a:defRPr sz="13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44" y="3"/>
            <a:ext cx="2949786" cy="498693"/>
          </a:xfrm>
          <a:prstGeom prst="rect">
            <a:avLst/>
          </a:prstGeom>
        </p:spPr>
        <p:txBody>
          <a:bodyPr vert="horz" lIns="95624" tIns="47814" rIns="95624" bIns="47814" rtlCol="0"/>
          <a:lstStyle>
            <a:lvl1pPr algn="r">
              <a:defRPr sz="1300"/>
            </a:lvl1pPr>
          </a:lstStyle>
          <a:p>
            <a:fld id="{77AA9483-565E-46D9-A842-79CD4DF778D0}" type="datetimeFigureOut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5" y="9440648"/>
            <a:ext cx="2949786" cy="498692"/>
          </a:xfrm>
          <a:prstGeom prst="rect">
            <a:avLst/>
          </a:prstGeom>
        </p:spPr>
        <p:txBody>
          <a:bodyPr vert="horz" lIns="95624" tIns="47814" rIns="95624" bIns="47814" rtlCol="0" anchor="b"/>
          <a:lstStyle>
            <a:lvl1pPr algn="l">
              <a:defRPr sz="1300"/>
            </a:lvl1pPr>
          </a:lstStyle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44" y="9440648"/>
            <a:ext cx="2949786" cy="498692"/>
          </a:xfrm>
          <a:prstGeom prst="rect">
            <a:avLst/>
          </a:prstGeom>
        </p:spPr>
        <p:txBody>
          <a:bodyPr vert="horz" lIns="95624" tIns="47814" rIns="95624" bIns="47814" rtlCol="0" anchor="b"/>
          <a:lstStyle>
            <a:lvl1pPr algn="r">
              <a:defRPr sz="1300"/>
            </a:lvl1pPr>
          </a:lstStyle>
          <a:p>
            <a:fld id="{F33174FD-3531-4AD8-AF7A-64487AF244F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454685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6" y="6"/>
            <a:ext cx="2949533" cy="497969"/>
          </a:xfrm>
          <a:prstGeom prst="rect">
            <a:avLst/>
          </a:prstGeom>
        </p:spPr>
        <p:txBody>
          <a:bodyPr vert="horz" lIns="88255" tIns="44127" rIns="88255" bIns="44127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146" y="6"/>
            <a:ext cx="2949532" cy="497969"/>
          </a:xfrm>
          <a:prstGeom prst="rect">
            <a:avLst/>
          </a:prstGeom>
        </p:spPr>
        <p:txBody>
          <a:bodyPr vert="horz" lIns="88255" tIns="44127" rIns="88255" bIns="44127" rtlCol="0"/>
          <a:lstStyle>
            <a:lvl1pPr algn="r">
              <a:defRPr sz="1200"/>
            </a:lvl1pPr>
          </a:lstStyle>
          <a:p>
            <a:fld id="{967D371C-0BC3-47E7-8070-1D8FD1977CE7}" type="datetimeFigureOut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9988" y="1243013"/>
            <a:ext cx="44704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8255" tIns="44127" rIns="88255" bIns="44127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480" y="4783900"/>
            <a:ext cx="5445760" cy="3912834"/>
          </a:xfrm>
          <a:prstGeom prst="rect">
            <a:avLst/>
          </a:prstGeom>
        </p:spPr>
        <p:txBody>
          <a:bodyPr vert="horz" lIns="88255" tIns="44127" rIns="88255" bIns="44127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6" y="9441374"/>
            <a:ext cx="2949533" cy="497969"/>
          </a:xfrm>
          <a:prstGeom prst="rect">
            <a:avLst/>
          </a:prstGeom>
        </p:spPr>
        <p:txBody>
          <a:bodyPr vert="horz" lIns="88255" tIns="44127" rIns="88255" bIns="44127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146" y="9441374"/>
            <a:ext cx="2949532" cy="497969"/>
          </a:xfrm>
          <a:prstGeom prst="rect">
            <a:avLst/>
          </a:prstGeom>
        </p:spPr>
        <p:txBody>
          <a:bodyPr vert="horz" lIns="88255" tIns="44127" rIns="88255" bIns="44127" rtlCol="0" anchor="b"/>
          <a:lstStyle>
            <a:lvl1pPr algn="r">
              <a:defRPr sz="1200"/>
            </a:lvl1pPr>
          </a:lstStyle>
          <a:p>
            <a:fld id="{8087B928-A29C-4023-B70B-14035D670E3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995196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4DCA-D378-4CBA-B2EB-93C479760CB0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9163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CBA4-CF1C-4256-B860-9AA9E7FB8F04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54079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E0B85-B1A1-420B-8C58-5608326397E3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22792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F2AD-7792-4694-8A8D-47038094A2F6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86931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3A5AA-51B3-4289-92E7-56B34844DC67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32433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D8A87-828D-49E8-A499-33D151351DDD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57634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88CF2-512A-43F6-A490-B679F1114C95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28328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687B-7EE4-45EB-8EF6-70E0D13ADE99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96728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E90B6-349F-44D5-A782-8BAC83707F4E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42946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95BB9-420E-4F1B-9995-3D589F84EF36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61817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4C5CE-5E4E-41FD-8680-1EA160B04991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3225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73DC1-41A9-4AF1-8DBE-785BCAA55A2A}" type="datetime1">
              <a:rPr kumimoji="1" lang="ja-JP" altLang="en-US" smtClean="0"/>
              <a:t>2019/2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89310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397560" y="428740"/>
            <a:ext cx="82768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kumimoji="0" lang="en-US" altLang="ja-JP" sz="1200" b="1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dditional file 1: Table </a:t>
            </a:r>
            <a:r>
              <a:rPr kumimoji="0" lang="en-US" altLang="ja-JP" sz="1200" b="1" kern="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1 </a:t>
            </a:r>
            <a:r>
              <a:rPr kumimoji="0" lang="en-US" altLang="ja-JP" sz="12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Baseline demographic variables of the eligible UC and CD patients for inclusion in this study</a:t>
            </a:r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7236525"/>
              </p:ext>
            </p:extLst>
          </p:nvPr>
        </p:nvGraphicFramePr>
        <p:xfrm>
          <a:off x="488696" y="684957"/>
          <a:ext cx="8387341" cy="5172160"/>
        </p:xfrm>
        <a:graphic>
          <a:graphicData uri="http://schemas.openxmlformats.org/drawingml/2006/table">
            <a:tbl>
              <a:tblPr/>
              <a:tblGrid>
                <a:gridCol w="2178530"/>
                <a:gridCol w="1416045"/>
                <a:gridCol w="689867"/>
                <a:gridCol w="835103"/>
                <a:gridCol w="835103"/>
                <a:gridCol w="835103"/>
                <a:gridCol w="798795"/>
                <a:gridCol w="798795"/>
              </a:tblGrid>
              <a:tr h="159104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Variable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ll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atients (n = 437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    UC (n = 368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   CD (n = 69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ge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year),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%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aediatric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atients,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≤ 1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2.1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0.9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8.8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9–6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5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59.3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57.1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9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71.0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lderly patients,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≥ 6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5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28.6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8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32.0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0.1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ender/Male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, n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%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3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(54.5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(54.3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(55.1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Duration of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disease (year),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edian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IQR)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[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]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.1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1.2–10.6) [406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3 (1.0–9.9) [344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.5 (3.8–15.0) [62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linical activity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ndex, median (IQR)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]</a:t>
                      </a:r>
                      <a:endParaRPr lang="en-US" sz="1000" b="0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Mayo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core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UC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6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5–7) [358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-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Meiryo UI" panose="020B0604030504040204" pitchFamily="50" charset="-128"/>
                        <a:ea typeface="Meiryo UI" panose="020B060403050404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OIBD score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CD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-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Meiryo UI" panose="020B0604030504040204" pitchFamily="50" charset="-128"/>
                        <a:ea typeface="Meiryo UI" panose="020B060403050404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1–4) [68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Disease extent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UC),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%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Ulcerative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00" b="0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</a:t>
                      </a:r>
                      <a:r>
                        <a:rPr lang="en-US" sz="1000" b="0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octitis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1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.9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-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Meiryo UI" panose="020B0604030504040204" pitchFamily="50" charset="-128"/>
                        <a:ea typeface="Meiryo UI" panose="020B060403050404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eft sided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UC</a:t>
                      </a:r>
                      <a:r>
                        <a:rPr lang="ja-JP" altLang="en-US" sz="10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2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30.4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-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Meiryo UI" panose="020B0604030504040204" pitchFamily="50" charset="-128"/>
                        <a:ea typeface="Meiryo UI" panose="020B060403050404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xtensive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UC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3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4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65.4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-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Meiryo UI" panose="020B0604030504040204" pitchFamily="50" charset="-128"/>
                        <a:ea typeface="Meiryo UI" panose="020B060403050404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Disease location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CD),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%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eal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1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-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Meiryo UI" panose="020B0604030504040204" pitchFamily="50" charset="-128"/>
                        <a:ea typeface="Meiryo UI" panose="020B060403050404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.4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lonic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2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-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Meiryo UI" panose="020B0604030504040204" pitchFamily="50" charset="-128"/>
                        <a:ea typeface="Meiryo UI" panose="020B060403050404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23.2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eocolonic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3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)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-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Meiryo UI" panose="020B0604030504040204" pitchFamily="50" charset="-128"/>
                        <a:ea typeface="Meiryo UI" panose="020B060403050404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72.5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Concomitant medications, n (%)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-aminosalicylat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61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82.6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08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83.7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3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76.8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rticosteroid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43.2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46.5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26.1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iopurine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5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34.5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2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33.2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42.0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alcineurin Inhibitor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5.5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6.3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.4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ti</a:t>
                      </a:r>
                      <a:r>
                        <a:rPr lang="en-US" sz="10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-TNF agent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8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20.4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13.0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1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59.4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ethotrexat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0.5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0.3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1.4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umber</a:t>
                      </a:r>
                      <a:r>
                        <a:rPr lang="en-US" sz="10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of concomitant 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0 (32.0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4 (33.7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 (23.2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mmunosuppressant medications, n (%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9 (38.7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46 (39.7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3 (33.3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1 (23.1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7 (20.9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4 (34.8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≥</a:t>
                      </a:r>
                      <a:r>
                        <a:rPr lang="ja-JP" altLang="en-US" sz="10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7 (6.2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 (5.7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 (8.7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umber of GMA sessions, median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IQR)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[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]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 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–10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435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–10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368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–10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67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aboratory data,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edian (IQR)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[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]</a:t>
                      </a:r>
                      <a:endParaRPr lang="en-US" sz="1000" b="0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RP,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g/L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.0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4–20.6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419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.5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3–17.6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353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.6 (3.1–32.4) [66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en-US" sz="1000" b="0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WBC,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</a:t>
                      </a:r>
                      <a:r>
                        <a:rPr lang="en-US" altLang="ja-JP" sz="1000" b="0" i="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/L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.3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.7–9.4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414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.5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.8–9.4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352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.9 (5.5–9.2) [62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ranulocyte,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%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1.5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3.8–78.4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324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1.5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3.7–78.5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271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1.4 (63.1–78.3) [53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BC,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</a:t>
                      </a:r>
                      <a:r>
                        <a:rPr lang="en-US" sz="1000" b="0" i="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/L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.1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.7–4.6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411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.1 (3.7–4.6) [349]</a:t>
                      </a:r>
                      <a:r>
                        <a:rPr lang="ja-JP" alt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.1 (3.7–4.5) [62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latelet, 10</a:t>
                      </a:r>
                      <a:r>
                        <a:rPr lang="en-US" sz="1000" b="0" i="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/L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3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44–397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409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0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44–394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348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17 (244–409) [61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Haematocrit, %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6.1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1.8–39.7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413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6.1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2–39.6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351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5.2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31.5–39.8) [62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6348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Haemoglobin, g/dL</a:t>
                      </a: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.8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.3–13.1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ja-JP" alt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[414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.9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.3–13.1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 [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52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.6 </a:t>
                      </a: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10.2–13.0) [62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230" marR="9230" marT="9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正方形/長方形 3"/>
          <p:cNvSpPr/>
          <p:nvPr/>
        </p:nvSpPr>
        <p:spPr>
          <a:xfrm>
            <a:off x="407951" y="5860619"/>
            <a:ext cx="851497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C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lcerative colitis,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rohn’s disease,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QR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quartile range,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yo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rtial Mayo,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IBD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national Organization for the Study of Inflammatory Bowel Diseases,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ur necrosis factor,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A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anulocyte and monocyte adsorptive apheresis,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P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-reactive protein,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BC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ite blood cell, 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C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 blood cell 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35655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46</TotalTime>
  <Words>699</Words>
  <Application>Microsoft Office PowerPoint</Application>
  <PresentationFormat>画面に合わせる (4:3)</PresentationFormat>
  <Paragraphs>16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Meiryo UI</vt:lpstr>
      <vt:lpstr>ＭＳ Ｐゴシック</vt:lpstr>
      <vt:lpstr>ＭＳ Ｐ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>JIM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kuma Seiichiro（国馬 誠一郎）</dc:creator>
  <cp:lastModifiedBy>hosoi eiji（細井　栄治）</cp:lastModifiedBy>
  <cp:revision>1016</cp:revision>
  <cp:lastPrinted>2018-11-09T05:42:12Z</cp:lastPrinted>
  <dcterms:created xsi:type="dcterms:W3CDTF">2017-02-06T05:38:59Z</dcterms:created>
  <dcterms:modified xsi:type="dcterms:W3CDTF">2019-02-21T08:08:59Z</dcterms:modified>
</cp:coreProperties>
</file>